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theme/themeOverride5.xml" ContentType="application/vnd.openxmlformats-officedocument.themeOverride+xml"/>
  <Override PartName="/ppt/charts/chart6.xml" ContentType="application/vnd.openxmlformats-officedocument.drawingml.chart+xml"/>
  <Override PartName="/ppt/theme/themeOverride6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3" d="100"/>
          <a:sy n="73" d="100"/>
        </p:scale>
        <p:origin x="-1122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Dr.%20Temesgen%20Samuel\Desktop\DATA%20BACKUP%202014\TS5-55\TS5-55=HCT-NFL.xlsx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Dr.%20Temesgen%20Samuel\Desktop\DATA%20BACKUP%202014\TS5-55\TS5-55=SW-NFL.xlsx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Dr.%20Temesgen%20Samuel\Desktop\DATA%20BACKUP%202014\TS5-55\TS5-55=HCT-NFL.xlsx" TargetMode="External"/><Relationship Id="rId1" Type="http://schemas.openxmlformats.org/officeDocument/2006/relationships/themeOverride" Target="../theme/themeOverride3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Dr.%20Temesgen%20Samuel\Desktop\DATA%20BACKUP%202014\TS5-55\TS5-55=SW-NFL.xlsx" TargetMode="External"/><Relationship Id="rId1" Type="http://schemas.openxmlformats.org/officeDocument/2006/relationships/themeOverride" Target="../theme/themeOverride4.xm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Dr.%20Temesgen%20Samuel\Desktop\DATA%20BACKUP%202014\TS5-55\TS5-55=HCT-NFL.xlsx" TargetMode="External"/><Relationship Id="rId1" Type="http://schemas.openxmlformats.org/officeDocument/2006/relationships/themeOverride" Target="../theme/themeOverride5.xml"/></Relationships>
</file>

<file path=ppt/charts/_rels/chart6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Dr.%20Temesgen%20Samuel\Desktop\DATA%20BACKUP%202014\TS5-55\TS5-55=SW-NFL.xlsx" TargetMode="External"/><Relationship Id="rId1" Type="http://schemas.openxmlformats.org/officeDocument/2006/relationships/themeOverride" Target="../theme/themeOverrid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ysClr val="windowText" lastClr="000000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GRAPH!$G$16:$G$22</c:f>
                <c:numCache>
                  <c:formatCode>General</c:formatCode>
                  <c:ptCount val="7"/>
                  <c:pt idx="0">
                    <c:v>8.6602540378443873</c:v>
                  </c:pt>
                  <c:pt idx="1">
                    <c:v>6.9282032302755088</c:v>
                  </c:pt>
                  <c:pt idx="2">
                    <c:v>9.5393920141694561</c:v>
                  </c:pt>
                  <c:pt idx="3">
                    <c:v>5.0332229568471663</c:v>
                  </c:pt>
                  <c:pt idx="4">
                    <c:v>10.263202878893768</c:v>
                  </c:pt>
                  <c:pt idx="5">
                    <c:v>4.0414518843273806</c:v>
                  </c:pt>
                  <c:pt idx="6">
                    <c:v>32.52691193458118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GRAPH!$B$16:$B$22</c:f>
              <c:numCache>
                <c:formatCode>General</c:formatCode>
                <c:ptCount val="7"/>
                <c:pt idx="0">
                  <c:v>10</c:v>
                </c:pt>
                <c:pt idx="1">
                  <c:v>5</c:v>
                </c:pt>
                <c:pt idx="2">
                  <c:v>2.5</c:v>
                </c:pt>
                <c:pt idx="3">
                  <c:v>1.25</c:v>
                </c:pt>
                <c:pt idx="4">
                  <c:v>0.6</c:v>
                </c:pt>
                <c:pt idx="5">
                  <c:v>0.3</c:v>
                </c:pt>
                <c:pt idx="6">
                  <c:v>0</c:v>
                </c:pt>
              </c:numCache>
            </c:numRef>
          </c:cat>
          <c:val>
            <c:numRef>
              <c:f>GRAPH!$F$16:$F$22</c:f>
              <c:numCache>
                <c:formatCode>0.0</c:formatCode>
                <c:ptCount val="7"/>
                <c:pt idx="0">
                  <c:v>154</c:v>
                </c:pt>
                <c:pt idx="1">
                  <c:v>156</c:v>
                </c:pt>
                <c:pt idx="2">
                  <c:v>114</c:v>
                </c:pt>
                <c:pt idx="3">
                  <c:v>68.333333333333329</c:v>
                </c:pt>
                <c:pt idx="4">
                  <c:v>128.33333333333334</c:v>
                </c:pt>
                <c:pt idx="5">
                  <c:v>234.33333333333334</c:v>
                </c:pt>
                <c:pt idx="6">
                  <c:v>57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5713920"/>
        <c:axId val="75736192"/>
      </c:barChart>
      <c:catAx>
        <c:axId val="757139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28575">
            <a:solidFill>
              <a:sysClr val="windowText" lastClr="000000"/>
            </a:solidFill>
          </a:ln>
        </c:spPr>
        <c:crossAx val="75736192"/>
        <c:crosses val="autoZero"/>
        <c:auto val="1"/>
        <c:lblAlgn val="ctr"/>
        <c:lblOffset val="100"/>
        <c:noMultiLvlLbl val="0"/>
      </c:catAx>
      <c:valAx>
        <c:axId val="75736192"/>
        <c:scaling>
          <c:orientation val="minMax"/>
        </c:scaling>
        <c:delete val="0"/>
        <c:axPos val="l"/>
        <c:majorGridlines/>
        <c:numFmt formatCode="0" sourceLinked="0"/>
        <c:majorTickMark val="out"/>
        <c:minorTickMark val="none"/>
        <c:tickLblPos val="nextTo"/>
        <c:spPr>
          <a:ln w="28575">
            <a:solidFill>
              <a:sysClr val="windowText" lastClr="000000"/>
            </a:solidFill>
          </a:ln>
        </c:spPr>
        <c:crossAx val="7571392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b="1"/>
      </a:pPr>
      <a:endParaRPr lang="en-US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ysClr val="windowText" lastClr="000000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2!$F$15:$F$21</c:f>
                <c:numCache>
                  <c:formatCode>General</c:formatCode>
                  <c:ptCount val="7"/>
                  <c:pt idx="0">
                    <c:v>53.106810611571596</c:v>
                  </c:pt>
                  <c:pt idx="1">
                    <c:v>128.7219225048062</c:v>
                  </c:pt>
                  <c:pt idx="2">
                    <c:v>73.654599313281182</c:v>
                  </c:pt>
                  <c:pt idx="3">
                    <c:v>441.23803099914221</c:v>
                  </c:pt>
                  <c:pt idx="4">
                    <c:v>492.6158070274779</c:v>
                  </c:pt>
                  <c:pt idx="5">
                    <c:v>920.93557501778241</c:v>
                  </c:pt>
                  <c:pt idx="6">
                    <c:v>93.34345183246652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Sheet2!$A$15:$A$21</c:f>
              <c:numCache>
                <c:formatCode>General</c:formatCode>
                <c:ptCount val="7"/>
                <c:pt idx="0">
                  <c:v>10</c:v>
                </c:pt>
                <c:pt idx="1">
                  <c:v>5</c:v>
                </c:pt>
                <c:pt idx="2">
                  <c:v>2.5</c:v>
                </c:pt>
                <c:pt idx="3">
                  <c:v>1.25</c:v>
                </c:pt>
                <c:pt idx="4">
                  <c:v>0.6</c:v>
                </c:pt>
                <c:pt idx="5">
                  <c:v>0.3</c:v>
                </c:pt>
                <c:pt idx="6">
                  <c:v>0</c:v>
                </c:pt>
              </c:numCache>
            </c:numRef>
          </c:cat>
          <c:val>
            <c:numRef>
              <c:f>Sheet2!$E$15:$E$21</c:f>
              <c:numCache>
                <c:formatCode>0.0</c:formatCode>
                <c:ptCount val="7"/>
                <c:pt idx="0">
                  <c:v>1365.6666666666667</c:v>
                </c:pt>
                <c:pt idx="1">
                  <c:v>1642.3333333333333</c:v>
                </c:pt>
                <c:pt idx="2">
                  <c:v>2619</c:v>
                </c:pt>
                <c:pt idx="3">
                  <c:v>6938</c:v>
                </c:pt>
                <c:pt idx="4">
                  <c:v>11619.666666666666</c:v>
                </c:pt>
                <c:pt idx="5">
                  <c:v>9192.6666666666661</c:v>
                </c:pt>
                <c:pt idx="6">
                  <c:v>109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5760384"/>
        <c:axId val="75761920"/>
      </c:barChart>
      <c:catAx>
        <c:axId val="757603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28575">
            <a:solidFill>
              <a:sysClr val="windowText" lastClr="000000"/>
            </a:solidFill>
          </a:ln>
        </c:spPr>
        <c:crossAx val="75761920"/>
        <c:crosses val="autoZero"/>
        <c:auto val="1"/>
        <c:lblAlgn val="ctr"/>
        <c:lblOffset val="100"/>
        <c:noMultiLvlLbl val="0"/>
      </c:catAx>
      <c:valAx>
        <c:axId val="75761920"/>
        <c:scaling>
          <c:orientation val="minMax"/>
        </c:scaling>
        <c:delete val="0"/>
        <c:axPos val="l"/>
        <c:majorGridlines/>
        <c:numFmt formatCode="0" sourceLinked="0"/>
        <c:majorTickMark val="out"/>
        <c:minorTickMark val="none"/>
        <c:tickLblPos val="nextTo"/>
        <c:spPr>
          <a:ln w="28575">
            <a:solidFill>
              <a:sysClr val="windowText" lastClr="000000"/>
            </a:solidFill>
          </a:ln>
        </c:spPr>
        <c:crossAx val="7576038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b="1"/>
      </a:pPr>
      <a:endParaRPr lang="en-US"/>
    </a:p>
  </c:tx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ysClr val="windowText" lastClr="000000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GRAPH!$G$27:$G$33</c:f>
                <c:numCache>
                  <c:formatCode>General</c:formatCode>
                  <c:ptCount val="7"/>
                  <c:pt idx="0">
                    <c:v>22.744962812309307</c:v>
                  </c:pt>
                  <c:pt idx="1">
                    <c:v>26.102362600602522</c:v>
                  </c:pt>
                  <c:pt idx="2">
                    <c:v>52.04805471869242</c:v>
                  </c:pt>
                  <c:pt idx="3">
                    <c:v>91.571465715763964</c:v>
                  </c:pt>
                  <c:pt idx="4">
                    <c:v>19.139836293274122</c:v>
                  </c:pt>
                  <c:pt idx="5">
                    <c:v>31.390019645316141</c:v>
                  </c:pt>
                  <c:pt idx="6">
                    <c:v>86.3732211587212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GRAPH!$B$27:$B$33</c:f>
              <c:numCache>
                <c:formatCode>General</c:formatCode>
                <c:ptCount val="7"/>
                <c:pt idx="0">
                  <c:v>20</c:v>
                </c:pt>
                <c:pt idx="1">
                  <c:v>10</c:v>
                </c:pt>
                <c:pt idx="2">
                  <c:v>5</c:v>
                </c:pt>
                <c:pt idx="3">
                  <c:v>2.5</c:v>
                </c:pt>
                <c:pt idx="4">
                  <c:v>1.25</c:v>
                </c:pt>
                <c:pt idx="5">
                  <c:v>0.6</c:v>
                </c:pt>
                <c:pt idx="6">
                  <c:v>0</c:v>
                </c:pt>
              </c:numCache>
            </c:numRef>
          </c:cat>
          <c:val>
            <c:numRef>
              <c:f>GRAPH!$F$27:$F$33</c:f>
              <c:numCache>
                <c:formatCode>0.0</c:formatCode>
                <c:ptCount val="7"/>
                <c:pt idx="0">
                  <c:v>1251.6666666666667</c:v>
                </c:pt>
                <c:pt idx="1">
                  <c:v>974.66666666666663</c:v>
                </c:pt>
                <c:pt idx="2">
                  <c:v>759</c:v>
                </c:pt>
                <c:pt idx="3">
                  <c:v>782.66666666666663</c:v>
                </c:pt>
                <c:pt idx="4">
                  <c:v>630.33333333333337</c:v>
                </c:pt>
                <c:pt idx="5">
                  <c:v>574.66666666666663</c:v>
                </c:pt>
                <c:pt idx="6">
                  <c:v>699.6666666666666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5794304"/>
        <c:axId val="75795840"/>
      </c:barChart>
      <c:catAx>
        <c:axId val="757943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28575">
            <a:solidFill>
              <a:sysClr val="windowText" lastClr="000000"/>
            </a:solidFill>
          </a:ln>
        </c:spPr>
        <c:crossAx val="75795840"/>
        <c:crosses val="autoZero"/>
        <c:auto val="1"/>
        <c:lblAlgn val="ctr"/>
        <c:lblOffset val="100"/>
        <c:noMultiLvlLbl val="0"/>
      </c:catAx>
      <c:valAx>
        <c:axId val="75795840"/>
        <c:scaling>
          <c:orientation val="minMax"/>
        </c:scaling>
        <c:delete val="0"/>
        <c:axPos val="l"/>
        <c:majorGridlines/>
        <c:numFmt formatCode="0" sourceLinked="0"/>
        <c:majorTickMark val="out"/>
        <c:minorTickMark val="none"/>
        <c:tickLblPos val="nextTo"/>
        <c:spPr>
          <a:ln w="28575">
            <a:solidFill>
              <a:sysClr val="windowText" lastClr="000000"/>
            </a:solidFill>
          </a:ln>
        </c:spPr>
        <c:crossAx val="7579430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b="1"/>
      </a:pPr>
      <a:endParaRPr lang="en-US"/>
    </a:p>
  </c:txPr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ysClr val="windowText" lastClr="000000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2!$F$26:$F$32</c:f>
                <c:numCache>
                  <c:formatCode>General</c:formatCode>
                  <c:ptCount val="7"/>
                  <c:pt idx="0">
                    <c:v>82.275958416376611</c:v>
                  </c:pt>
                  <c:pt idx="1">
                    <c:v>56.871199506721617</c:v>
                  </c:pt>
                  <c:pt idx="2">
                    <c:v>107.43525181863416</c:v>
                  </c:pt>
                  <c:pt idx="3">
                    <c:v>103.00647228855735</c:v>
                  </c:pt>
                  <c:pt idx="4">
                    <c:v>102.10941843597648</c:v>
                  </c:pt>
                  <c:pt idx="5">
                    <c:v>52</c:v>
                  </c:pt>
                  <c:pt idx="6">
                    <c:v>74.66145815166841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Sheet2!$A$26:$A$32</c:f>
              <c:numCache>
                <c:formatCode>General</c:formatCode>
                <c:ptCount val="7"/>
                <c:pt idx="0">
                  <c:v>20</c:v>
                </c:pt>
                <c:pt idx="1">
                  <c:v>10</c:v>
                </c:pt>
                <c:pt idx="2">
                  <c:v>5</c:v>
                </c:pt>
                <c:pt idx="3">
                  <c:v>2.5</c:v>
                </c:pt>
                <c:pt idx="4">
                  <c:v>1.25</c:v>
                </c:pt>
                <c:pt idx="5">
                  <c:v>0.6</c:v>
                </c:pt>
                <c:pt idx="6">
                  <c:v>0</c:v>
                </c:pt>
              </c:numCache>
            </c:numRef>
          </c:cat>
          <c:val>
            <c:numRef>
              <c:f>Sheet2!$E$26:$E$32</c:f>
              <c:numCache>
                <c:formatCode>0.0</c:formatCode>
                <c:ptCount val="7"/>
                <c:pt idx="0">
                  <c:v>1133.3333333333333</c:v>
                </c:pt>
                <c:pt idx="1">
                  <c:v>1012.6666666666666</c:v>
                </c:pt>
                <c:pt idx="2">
                  <c:v>955.66666666666663</c:v>
                </c:pt>
                <c:pt idx="3">
                  <c:v>917.33333333333337</c:v>
                </c:pt>
                <c:pt idx="4">
                  <c:v>1121.6666666666667</c:v>
                </c:pt>
                <c:pt idx="5">
                  <c:v>961</c:v>
                </c:pt>
                <c:pt idx="6">
                  <c:v>1124.666666666666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5807744"/>
        <c:axId val="75838208"/>
      </c:barChart>
      <c:catAx>
        <c:axId val="758077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28575">
            <a:solidFill>
              <a:sysClr val="windowText" lastClr="000000"/>
            </a:solidFill>
          </a:ln>
        </c:spPr>
        <c:crossAx val="75838208"/>
        <c:crosses val="autoZero"/>
        <c:auto val="1"/>
        <c:lblAlgn val="ctr"/>
        <c:lblOffset val="100"/>
        <c:noMultiLvlLbl val="0"/>
      </c:catAx>
      <c:valAx>
        <c:axId val="75838208"/>
        <c:scaling>
          <c:orientation val="minMax"/>
        </c:scaling>
        <c:delete val="0"/>
        <c:axPos val="l"/>
        <c:majorGridlines/>
        <c:numFmt formatCode="0" sourceLinked="0"/>
        <c:majorTickMark val="out"/>
        <c:minorTickMark val="none"/>
        <c:tickLblPos val="nextTo"/>
        <c:spPr>
          <a:ln w="28575">
            <a:solidFill>
              <a:sysClr val="windowText" lastClr="000000"/>
            </a:solidFill>
          </a:ln>
        </c:spPr>
        <c:crossAx val="7580774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b="1"/>
      </a:pPr>
      <a:endParaRPr lang="en-US"/>
    </a:p>
  </c:txPr>
  <c:externalData r:id="rId2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ysClr val="windowText" lastClr="000000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GRAPH!$G$38:$G$44</c:f>
                <c:numCache>
                  <c:formatCode>General</c:formatCode>
                  <c:ptCount val="7"/>
                  <c:pt idx="0">
                    <c:v>28.0237994093116</c:v>
                  </c:pt>
                  <c:pt idx="1">
                    <c:v>15.0996688705415</c:v>
                  </c:pt>
                  <c:pt idx="2">
                    <c:v>10.816653826391969</c:v>
                  </c:pt>
                  <c:pt idx="3">
                    <c:v>24.00694344004112</c:v>
                  </c:pt>
                  <c:pt idx="4">
                    <c:v>14.0118997046558</c:v>
                  </c:pt>
                  <c:pt idx="5">
                    <c:v>49.929950931279713</c:v>
                  </c:pt>
                  <c:pt idx="6">
                    <c:v>50.50082507576815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GRAPH!$B$38:$B$44</c:f>
              <c:numCache>
                <c:formatCode>General</c:formatCode>
                <c:ptCount val="7"/>
                <c:pt idx="0">
                  <c:v>50</c:v>
                </c:pt>
                <c:pt idx="1">
                  <c:v>25</c:v>
                </c:pt>
                <c:pt idx="2">
                  <c:v>12.5</c:v>
                </c:pt>
                <c:pt idx="3">
                  <c:v>6.25</c:v>
                </c:pt>
                <c:pt idx="4">
                  <c:v>3.1</c:v>
                </c:pt>
                <c:pt idx="5">
                  <c:v>1.6</c:v>
                </c:pt>
                <c:pt idx="6">
                  <c:v>0</c:v>
                </c:pt>
              </c:numCache>
            </c:numRef>
          </c:cat>
          <c:val>
            <c:numRef>
              <c:f>GRAPH!$F$38:$F$44</c:f>
              <c:numCache>
                <c:formatCode>0.0</c:formatCode>
                <c:ptCount val="7"/>
                <c:pt idx="0">
                  <c:v>317.66666666666669</c:v>
                </c:pt>
                <c:pt idx="1">
                  <c:v>339</c:v>
                </c:pt>
                <c:pt idx="2">
                  <c:v>380</c:v>
                </c:pt>
                <c:pt idx="3">
                  <c:v>431.66666666666669</c:v>
                </c:pt>
                <c:pt idx="4">
                  <c:v>468.66666666666669</c:v>
                </c:pt>
                <c:pt idx="5">
                  <c:v>471</c:v>
                </c:pt>
                <c:pt idx="6">
                  <c:v>541.3333333333333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5866496"/>
        <c:axId val="75868032"/>
      </c:barChart>
      <c:catAx>
        <c:axId val="758664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28575">
            <a:solidFill>
              <a:sysClr val="windowText" lastClr="000000"/>
            </a:solidFill>
          </a:ln>
        </c:spPr>
        <c:crossAx val="75868032"/>
        <c:crosses val="autoZero"/>
        <c:auto val="1"/>
        <c:lblAlgn val="ctr"/>
        <c:lblOffset val="100"/>
        <c:noMultiLvlLbl val="0"/>
      </c:catAx>
      <c:valAx>
        <c:axId val="75868032"/>
        <c:scaling>
          <c:orientation val="minMax"/>
        </c:scaling>
        <c:delete val="0"/>
        <c:axPos val="l"/>
        <c:majorGridlines/>
        <c:numFmt formatCode="0" sourceLinked="0"/>
        <c:majorTickMark val="out"/>
        <c:minorTickMark val="none"/>
        <c:tickLblPos val="nextTo"/>
        <c:spPr>
          <a:ln w="28575">
            <a:solidFill>
              <a:sysClr val="windowText" lastClr="000000"/>
            </a:solidFill>
          </a:ln>
        </c:spPr>
        <c:crossAx val="7586649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b="1"/>
      </a:pPr>
      <a:endParaRPr lang="en-US"/>
    </a:p>
  </c:txPr>
  <c:externalData r:id="rId2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ysClr val="windowText" lastClr="000000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2!$F$37:$F$43</c:f>
                <c:numCache>
                  <c:formatCode>General</c:formatCode>
                  <c:ptCount val="7"/>
                  <c:pt idx="0">
                    <c:v>68.549252366455462</c:v>
                  </c:pt>
                  <c:pt idx="1">
                    <c:v>55.054518434003214</c:v>
                  </c:pt>
                  <c:pt idx="2">
                    <c:v>160.3652081967906</c:v>
                  </c:pt>
                  <c:pt idx="3">
                    <c:v>65.023072828035438</c:v>
                  </c:pt>
                  <c:pt idx="4">
                    <c:v>41.356176483487125</c:v>
                  </c:pt>
                  <c:pt idx="5">
                    <c:v>65.607418279744351</c:v>
                  </c:pt>
                  <c:pt idx="6">
                    <c:v>129.7394825538211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Sheet2!$A$37:$A$43</c:f>
              <c:numCache>
                <c:formatCode>General</c:formatCode>
                <c:ptCount val="7"/>
                <c:pt idx="0">
                  <c:v>50</c:v>
                </c:pt>
                <c:pt idx="1">
                  <c:v>25</c:v>
                </c:pt>
                <c:pt idx="2">
                  <c:v>12.5</c:v>
                </c:pt>
                <c:pt idx="3">
                  <c:v>6.25</c:v>
                </c:pt>
                <c:pt idx="4">
                  <c:v>3.1</c:v>
                </c:pt>
                <c:pt idx="5">
                  <c:v>1.6</c:v>
                </c:pt>
                <c:pt idx="6">
                  <c:v>0</c:v>
                </c:pt>
              </c:numCache>
            </c:numRef>
          </c:cat>
          <c:val>
            <c:numRef>
              <c:f>Sheet2!$E$37:$E$43</c:f>
              <c:numCache>
                <c:formatCode>0.0</c:formatCode>
                <c:ptCount val="7"/>
                <c:pt idx="0">
                  <c:v>1123</c:v>
                </c:pt>
                <c:pt idx="1">
                  <c:v>977</c:v>
                </c:pt>
                <c:pt idx="2">
                  <c:v>1029</c:v>
                </c:pt>
                <c:pt idx="3">
                  <c:v>967</c:v>
                </c:pt>
                <c:pt idx="4">
                  <c:v>860.33333333333337</c:v>
                </c:pt>
                <c:pt idx="5">
                  <c:v>921.33333333333337</c:v>
                </c:pt>
                <c:pt idx="6">
                  <c:v>933.3333333333333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0152064"/>
        <c:axId val="80153600"/>
      </c:barChart>
      <c:catAx>
        <c:axId val="801520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28575">
            <a:solidFill>
              <a:sysClr val="windowText" lastClr="000000"/>
            </a:solidFill>
          </a:ln>
        </c:spPr>
        <c:crossAx val="80153600"/>
        <c:crosses val="autoZero"/>
        <c:auto val="1"/>
        <c:lblAlgn val="ctr"/>
        <c:lblOffset val="100"/>
        <c:noMultiLvlLbl val="0"/>
      </c:catAx>
      <c:valAx>
        <c:axId val="80153600"/>
        <c:scaling>
          <c:orientation val="minMax"/>
        </c:scaling>
        <c:delete val="0"/>
        <c:axPos val="l"/>
        <c:majorGridlines/>
        <c:numFmt formatCode="0" sourceLinked="0"/>
        <c:majorTickMark val="out"/>
        <c:minorTickMark val="none"/>
        <c:tickLblPos val="nextTo"/>
        <c:spPr>
          <a:ln w="28575">
            <a:solidFill>
              <a:sysClr val="windowText" lastClr="000000"/>
            </a:solidFill>
          </a:ln>
        </c:spPr>
        <c:crossAx val="8015206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b="1"/>
      </a:pPr>
      <a:endParaRPr lang="en-US"/>
    </a:p>
  </c:txPr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9C2E67-CC53-48AA-AC59-060770DDDB6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7/2014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CAC7D-C5A1-4D59-9582-85F2785F148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76979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9C2E67-CC53-48AA-AC59-060770DDDB6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7/2014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CAC7D-C5A1-4D59-9582-85F2785F148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099734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9C2E67-CC53-48AA-AC59-060770DDDB6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7/2014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CAC7D-C5A1-4D59-9582-85F2785F148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035550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9C2E67-CC53-48AA-AC59-060770DDDB6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7/2014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CAC7D-C5A1-4D59-9582-85F2785F148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841908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9C2E67-CC53-48AA-AC59-060770DDDB6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7/2014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CAC7D-C5A1-4D59-9582-85F2785F148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228333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9C2E67-CC53-48AA-AC59-060770DDDB6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7/2014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CAC7D-C5A1-4D59-9582-85F2785F148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461291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9C2E67-CC53-48AA-AC59-060770DDDB6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7/2014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CAC7D-C5A1-4D59-9582-85F2785F148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849634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9C2E67-CC53-48AA-AC59-060770DDDB6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7/2014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CAC7D-C5A1-4D59-9582-85F2785F148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670639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9C2E67-CC53-48AA-AC59-060770DDDB6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7/2014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CAC7D-C5A1-4D59-9582-85F2785F148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874740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9C2E67-CC53-48AA-AC59-060770DDDB6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7/2014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CAC7D-C5A1-4D59-9582-85F2785F148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222310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9C2E67-CC53-48AA-AC59-060770DDDB6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7/2014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CAC7D-C5A1-4D59-9582-85F2785F148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936694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9C2E67-CC53-48AA-AC59-060770DDDB6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7/2014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0CAC7D-C5A1-4D59-9582-85F2785F148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227961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2" name="Group 41"/>
          <p:cNvGrpSpPr/>
          <p:nvPr/>
        </p:nvGrpSpPr>
        <p:grpSpPr>
          <a:xfrm>
            <a:off x="110836" y="633366"/>
            <a:ext cx="8929996" cy="4573051"/>
            <a:chOff x="-91480" y="1295400"/>
            <a:chExt cx="8929996" cy="4573051"/>
          </a:xfrm>
        </p:grpSpPr>
        <p:grpSp>
          <p:nvGrpSpPr>
            <p:cNvPr id="24" name="Group 23"/>
            <p:cNvGrpSpPr/>
            <p:nvPr/>
          </p:nvGrpSpPr>
          <p:grpSpPr>
            <a:xfrm>
              <a:off x="-91480" y="1295400"/>
              <a:ext cx="8929996" cy="4400778"/>
              <a:chOff x="-225909" y="185954"/>
              <a:chExt cx="8929996" cy="4400778"/>
            </a:xfrm>
          </p:grpSpPr>
          <p:graphicFrame>
            <p:nvGraphicFramePr>
              <p:cNvPr id="2" name="Chart 1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036403572"/>
                  </p:ext>
                </p:extLst>
              </p:nvPr>
            </p:nvGraphicFramePr>
            <p:xfrm>
              <a:off x="479920" y="761999"/>
              <a:ext cx="2720480" cy="1895633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graphicFrame>
            <p:nvGraphicFramePr>
              <p:cNvPr id="5" name="Chart 4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384984408"/>
                  </p:ext>
                </p:extLst>
              </p:nvPr>
            </p:nvGraphicFramePr>
            <p:xfrm>
              <a:off x="409659" y="2689413"/>
              <a:ext cx="2750485" cy="189731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graphicFrame>
            <p:nvGraphicFramePr>
              <p:cNvPr id="3" name="Chart 2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976778171"/>
                  </p:ext>
                </p:extLst>
              </p:nvPr>
            </p:nvGraphicFramePr>
            <p:xfrm>
              <a:off x="3150918" y="762000"/>
              <a:ext cx="2744770" cy="1892193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graphicFrame>
            <p:nvGraphicFramePr>
              <p:cNvPr id="6" name="Chart 5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913292970"/>
                  </p:ext>
                </p:extLst>
              </p:nvPr>
            </p:nvGraphicFramePr>
            <p:xfrm>
              <a:off x="3071053" y="2678207"/>
              <a:ext cx="2760486" cy="190676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graphicFrame>
            <p:nvGraphicFramePr>
              <p:cNvPr id="4" name="Chart 3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503318135"/>
                  </p:ext>
                </p:extLst>
              </p:nvPr>
            </p:nvGraphicFramePr>
            <p:xfrm>
              <a:off x="5993049" y="748393"/>
              <a:ext cx="2550450" cy="1892192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  <p:graphicFrame>
            <p:nvGraphicFramePr>
              <p:cNvPr id="7" name="Chart 6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495576322"/>
                  </p:ext>
                </p:extLst>
              </p:nvPr>
            </p:nvGraphicFramePr>
            <p:xfrm>
              <a:off x="5943600" y="2667000"/>
              <a:ext cx="2760487" cy="1916207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7"/>
              </a:graphicData>
            </a:graphic>
          </p:graphicFrame>
          <p:sp>
            <p:nvSpPr>
              <p:cNvPr id="8" name="TextBox 7"/>
              <p:cNvSpPr txBox="1"/>
              <p:nvPr/>
            </p:nvSpPr>
            <p:spPr>
              <a:xfrm>
                <a:off x="1526968" y="228600"/>
                <a:ext cx="731995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400" b="1" dirty="0" smtClean="0">
                    <a:solidFill>
                      <a:prstClr val="black"/>
                    </a:solidFill>
                  </a:rPr>
                  <a:t>CPT </a:t>
                </a:r>
                <a:endParaRPr lang="en-US" sz="2400" b="1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4194796" y="228600"/>
                <a:ext cx="776175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400" b="1" dirty="0" smtClean="0">
                    <a:solidFill>
                      <a:prstClr val="black"/>
                    </a:solidFill>
                  </a:rPr>
                  <a:t>5-FU</a:t>
                </a:r>
                <a:endParaRPr lang="en-US" sz="2400" b="1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6494971" y="185954"/>
                <a:ext cx="1567865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400" b="1" dirty="0" err="1" smtClean="0">
                    <a:solidFill>
                      <a:prstClr val="black"/>
                    </a:solidFill>
                  </a:rPr>
                  <a:t>Oxaliplatin</a:t>
                </a:r>
                <a:endParaRPr lang="en-US" sz="2400" b="1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 rot="16200000">
                <a:off x="-577095" y="3334908"/>
                <a:ext cx="1225592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800" b="1" dirty="0" smtClean="0">
                    <a:solidFill>
                      <a:prstClr val="black"/>
                    </a:solidFill>
                  </a:rPr>
                  <a:t>SW480</a:t>
                </a:r>
                <a:endParaRPr lang="en-US" sz="2800" b="1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 rot="16200000">
                <a:off x="-628966" y="1265586"/>
                <a:ext cx="1329338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800" b="1" dirty="0" smtClean="0">
                    <a:solidFill>
                      <a:prstClr val="black"/>
                    </a:solidFill>
                  </a:rPr>
                  <a:t>HCT116</a:t>
                </a:r>
                <a:endParaRPr lang="en-US" sz="2800" b="1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8" name="Left Bracket 17"/>
              <p:cNvSpPr/>
              <p:nvPr/>
            </p:nvSpPr>
            <p:spPr>
              <a:xfrm>
                <a:off x="207381" y="665018"/>
                <a:ext cx="89934" cy="1849582"/>
              </a:xfrm>
              <a:prstGeom prst="leftBracket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b="1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9" name="Left Bracket 18"/>
              <p:cNvSpPr/>
              <p:nvPr/>
            </p:nvSpPr>
            <p:spPr>
              <a:xfrm>
                <a:off x="207378" y="2667000"/>
                <a:ext cx="89934" cy="1849582"/>
              </a:xfrm>
              <a:prstGeom prst="leftBracket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b="1" dirty="0">
                  <a:solidFill>
                    <a:prstClr val="black"/>
                  </a:solidFill>
                </a:endParaRPr>
              </a:p>
            </p:txBody>
          </p:sp>
          <p:cxnSp>
            <p:nvCxnSpPr>
              <p:cNvPr id="21" name="Straight Connector 20"/>
              <p:cNvCxnSpPr/>
              <p:nvPr/>
            </p:nvCxnSpPr>
            <p:spPr>
              <a:xfrm>
                <a:off x="838200" y="665018"/>
                <a:ext cx="20574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Straight Connector 21"/>
              <p:cNvCxnSpPr/>
              <p:nvPr/>
            </p:nvCxnSpPr>
            <p:spPr>
              <a:xfrm>
                <a:off x="3637248" y="651163"/>
                <a:ext cx="20574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Straight Connector 22"/>
              <p:cNvCxnSpPr/>
              <p:nvPr/>
            </p:nvCxnSpPr>
            <p:spPr>
              <a:xfrm>
                <a:off x="6324600" y="637308"/>
                <a:ext cx="20574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6" name="TextBox 25"/>
            <p:cNvSpPr txBox="1"/>
            <p:nvPr/>
          </p:nvSpPr>
          <p:spPr>
            <a:xfrm>
              <a:off x="1816624" y="3618152"/>
              <a:ext cx="4058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prstClr val="black"/>
                  </a:solidFill>
                </a:rPr>
                <a:t>µM</a:t>
              </a:r>
              <a:endParaRPr lang="en-US" sz="1200" dirty="0">
                <a:solidFill>
                  <a:prstClr val="black"/>
                </a:solidFill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4495937" y="3640413"/>
              <a:ext cx="4058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prstClr val="black"/>
                  </a:solidFill>
                </a:rPr>
                <a:t>µM</a:t>
              </a:r>
              <a:endParaRPr lang="en-US" sz="1200" dirty="0">
                <a:solidFill>
                  <a:prstClr val="black"/>
                </a:solidFill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7282125" y="3626732"/>
              <a:ext cx="4058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prstClr val="black"/>
                  </a:solidFill>
                </a:rPr>
                <a:t>µM</a:t>
              </a:r>
              <a:endParaRPr lang="en-US" sz="1200" dirty="0">
                <a:solidFill>
                  <a:prstClr val="black"/>
                </a:solidFill>
              </a:endParaRPr>
            </a:p>
          </p:txBody>
        </p:sp>
        <p:cxnSp>
          <p:nvCxnSpPr>
            <p:cNvPr id="30" name="Straight Connector 29"/>
            <p:cNvCxnSpPr/>
            <p:nvPr/>
          </p:nvCxnSpPr>
          <p:spPr>
            <a:xfrm>
              <a:off x="1044632" y="3698492"/>
              <a:ext cx="20574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/>
            <p:cNvCxnSpPr/>
            <p:nvPr/>
          </p:nvCxnSpPr>
          <p:spPr>
            <a:xfrm>
              <a:off x="3771677" y="3686300"/>
              <a:ext cx="20574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/>
            <p:cNvCxnSpPr/>
            <p:nvPr/>
          </p:nvCxnSpPr>
          <p:spPr>
            <a:xfrm>
              <a:off x="6498722" y="3686300"/>
              <a:ext cx="20574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/>
            <p:cNvCxnSpPr/>
            <p:nvPr/>
          </p:nvCxnSpPr>
          <p:spPr>
            <a:xfrm>
              <a:off x="1044632" y="5630344"/>
              <a:ext cx="20574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36"/>
            <p:cNvCxnSpPr/>
            <p:nvPr/>
          </p:nvCxnSpPr>
          <p:spPr>
            <a:xfrm>
              <a:off x="3688612" y="5630344"/>
              <a:ext cx="20574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Connector 37"/>
            <p:cNvCxnSpPr/>
            <p:nvPr/>
          </p:nvCxnSpPr>
          <p:spPr>
            <a:xfrm>
              <a:off x="6588453" y="5621888"/>
              <a:ext cx="20574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TextBox 38"/>
            <p:cNvSpPr txBox="1"/>
            <p:nvPr/>
          </p:nvSpPr>
          <p:spPr>
            <a:xfrm>
              <a:off x="1899689" y="5581383"/>
              <a:ext cx="4058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prstClr val="black"/>
                  </a:solidFill>
                </a:rPr>
                <a:t>µM</a:t>
              </a:r>
              <a:endParaRPr lang="en-US" sz="1200" dirty="0">
                <a:solidFill>
                  <a:prstClr val="black"/>
                </a:solidFill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4579002" y="5591452"/>
              <a:ext cx="4058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prstClr val="black"/>
                  </a:solidFill>
                </a:rPr>
                <a:t>µM</a:t>
              </a:r>
              <a:endParaRPr lang="en-US" sz="1200" dirty="0">
                <a:solidFill>
                  <a:prstClr val="black"/>
                </a:solidFill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7365190" y="5565579"/>
              <a:ext cx="4058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prstClr val="black"/>
                  </a:solidFill>
                </a:rPr>
                <a:t>µM</a:t>
              </a:r>
              <a:endParaRPr lang="en-US" sz="1200" dirty="0">
                <a:solidFill>
                  <a:prstClr val="black"/>
                </a:solidFill>
              </a:endParaRPr>
            </a:p>
          </p:txBody>
        </p:sp>
      </p:grpSp>
      <p:sp>
        <p:nvSpPr>
          <p:cNvPr id="12" name="TextBox 11"/>
          <p:cNvSpPr txBox="1"/>
          <p:nvPr/>
        </p:nvSpPr>
        <p:spPr>
          <a:xfrm>
            <a:off x="125319" y="166737"/>
            <a:ext cx="3351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u="sng" dirty="0" smtClean="0"/>
              <a:t>Samuel et al. Supplemental Fig. 1</a:t>
            </a:r>
            <a:endParaRPr lang="en-US" b="1" u="sng" dirty="0"/>
          </a:p>
        </p:txBody>
      </p:sp>
      <p:sp>
        <p:nvSpPr>
          <p:cNvPr id="13" name="TextBox 12"/>
          <p:cNvSpPr txBox="1"/>
          <p:nvPr/>
        </p:nvSpPr>
        <p:spPr>
          <a:xfrm rot="16200000">
            <a:off x="-64049" y="1852554"/>
            <a:ext cx="16425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Luciferase units</a:t>
            </a:r>
            <a:endParaRPr lang="en-US" dirty="0"/>
          </a:p>
        </p:txBody>
      </p:sp>
      <p:sp>
        <p:nvSpPr>
          <p:cNvPr id="43" name="TextBox 42"/>
          <p:cNvSpPr txBox="1"/>
          <p:nvPr/>
        </p:nvSpPr>
        <p:spPr>
          <a:xfrm rot="16200000">
            <a:off x="-103184" y="3760785"/>
            <a:ext cx="16425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Luciferase unit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37682762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35</TotalTime>
  <Words>23</Words>
  <Application>Microsoft Office PowerPoint</Application>
  <PresentationFormat>On-screen Show (4:3)</PresentationFormat>
  <Paragraphs>1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1_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. Temesgen Samuel</dc:creator>
  <cp:lastModifiedBy>Dr. Temesgen Samuel</cp:lastModifiedBy>
  <cp:revision>7</cp:revision>
  <dcterms:created xsi:type="dcterms:W3CDTF">2006-08-16T00:00:00Z</dcterms:created>
  <dcterms:modified xsi:type="dcterms:W3CDTF">2014-07-07T05:35:36Z</dcterms:modified>
</cp:coreProperties>
</file>